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501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3430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256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0677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924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1336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432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7514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8208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243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9028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851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132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03DCA6E8-376C-4C10-A632-9894716E7973}"/>
              </a:ext>
            </a:extLst>
          </p:cNvPr>
          <p:cNvGrpSpPr/>
          <p:nvPr/>
        </p:nvGrpSpPr>
        <p:grpSpPr>
          <a:xfrm>
            <a:off x="195263" y="2293866"/>
            <a:ext cx="6464300" cy="5318197"/>
            <a:chOff x="266955" y="1311668"/>
            <a:chExt cx="6464300" cy="5318197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E04030FF-DB1A-44F2-909F-C0B2A8391A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41071798"/>
                </p:ext>
              </p:extLst>
            </p:nvPr>
          </p:nvGraphicFramePr>
          <p:xfrm>
            <a:off x="270130" y="1562565"/>
            <a:ext cx="3249612" cy="23034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811316" imgH="2700075" progId="Prism10.Document">
                    <p:embed/>
                  </p:oleObj>
                </mc:Choice>
                <mc:Fallback>
                  <p:oleObj name="Prism 10" r:id="rId2" imgW="3811316" imgH="2700075" progId="Prism10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E04030FF-DB1A-44F2-909F-C0B2A8391AA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0130" y="1562565"/>
                          <a:ext cx="3249612" cy="23034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1DA453AA-1713-457F-8C14-EDD03482E6BD}"/>
                </a:ext>
              </a:extLst>
            </p:cNvPr>
            <p:cNvSpPr txBox="1"/>
            <p:nvPr/>
          </p:nvSpPr>
          <p:spPr>
            <a:xfrm>
              <a:off x="638887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l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 (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e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4737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405</a:t>
              </a:r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088BD21A-0001-4496-BB7E-63A79A8CE6C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59199836"/>
                </p:ext>
              </p:extLst>
            </p:nvPr>
          </p:nvGraphicFramePr>
          <p:xfrm>
            <a:off x="3457830" y="1610190"/>
            <a:ext cx="3198812" cy="22653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811316" imgH="2700075" progId="Prism9.Document">
                    <p:embed/>
                  </p:oleObj>
                </mc:Choice>
                <mc:Fallback>
                  <p:oleObj name="Prism 9" r:id="rId4" imgW="3811316" imgH="2700075" progId="Prism9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088BD21A-0001-4496-BB7E-63A79A8CE6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457830" y="1610190"/>
                          <a:ext cx="3198812" cy="22653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5B58DCBB-CE58-49C3-B8C8-0A8BA21BAB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94592093"/>
                </p:ext>
              </p:extLst>
            </p:nvPr>
          </p:nvGraphicFramePr>
          <p:xfrm>
            <a:off x="266955" y="4289890"/>
            <a:ext cx="3303587" cy="2339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3811316" imgH="2700075" progId="Prism9.Document">
                    <p:embed/>
                  </p:oleObj>
                </mc:Choice>
                <mc:Fallback>
                  <p:oleObj name="Prism 9" r:id="rId6" imgW="3811316" imgH="2700075" progId="Prism9.Document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5B58DCBB-CE58-49C3-B8C8-0A8BA21BAB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66955" y="4289890"/>
                          <a:ext cx="3303587" cy="2339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CC387AD8-3011-48AB-8BCD-1362683095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73308164"/>
                </p:ext>
              </p:extLst>
            </p:nvPr>
          </p:nvGraphicFramePr>
          <p:xfrm>
            <a:off x="3459417" y="4304177"/>
            <a:ext cx="3271838" cy="23256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797631" imgH="2700075" progId="Prism10.Document">
                    <p:embed/>
                  </p:oleObj>
                </mc:Choice>
                <mc:Fallback>
                  <p:oleObj name="Prism 10" r:id="rId8" imgW="3797631" imgH="2700075" progId="Prism10.Document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:a16="http://schemas.microsoft.com/office/drawing/2014/main" id="{CC387AD8-3011-48AB-8BCD-1362683095E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459417" y="4304177"/>
                          <a:ext cx="3271838" cy="23256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BB012CCE-C7F6-42D5-B55D-2C2A437A9B09}"/>
                </a:ext>
              </a:extLst>
            </p:cNvPr>
            <p:cNvSpPr txBox="1"/>
            <p:nvPr/>
          </p:nvSpPr>
          <p:spPr>
            <a:xfrm>
              <a:off x="3800099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1771 ; p=0.4682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CC7964F2-44FA-445E-B37B-E87DD644AE9C}"/>
                </a:ext>
              </a:extLst>
            </p:cNvPr>
            <p:cNvSpPr txBox="1"/>
            <p:nvPr/>
          </p:nvSpPr>
          <p:spPr>
            <a:xfrm>
              <a:off x="638887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itical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5245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211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708C28DB-5DC9-4DAC-A7E9-DEEC504B5A65}"/>
                </a:ext>
              </a:extLst>
            </p:cNvPr>
            <p:cNvSpPr txBox="1"/>
            <p:nvPr/>
          </p:nvSpPr>
          <p:spPr>
            <a:xfrm>
              <a:off x="3800099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CC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5421 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 0165</a:t>
              </a:r>
            </a:p>
          </p:txBody>
        </p:sp>
      </p:grp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43E349A-8E87-4F36-AE53-494FC4AB45C8}"/>
              </a:ext>
            </a:extLst>
          </p:cNvPr>
          <p:cNvSpPr txBox="1"/>
          <p:nvPr/>
        </p:nvSpPr>
        <p:spPr>
          <a:xfrm>
            <a:off x="405340" y="379725"/>
            <a:ext cx="59659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's correlation between the levels of CD4+ Th1 and the express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se cells in the different cohorts. Pearson's coefficient r and p-values were calculated with GraphPad Software Inc. (San Diego, CA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739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8</TotalTime>
  <Words>86</Words>
  <Application>Microsoft Office PowerPoint</Application>
  <PresentationFormat>A4 (210 x 297 mm)</PresentationFormat>
  <Paragraphs>9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Tema de Office</vt:lpstr>
      <vt:lpstr>Prism 10</vt:lpstr>
      <vt:lpstr>Prism 9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yte Coiras</cp:lastModifiedBy>
  <cp:revision>50</cp:revision>
  <cp:lastPrinted>2024-02-23T14:10:25Z</cp:lastPrinted>
  <dcterms:created xsi:type="dcterms:W3CDTF">2024-02-22T09:28:26Z</dcterms:created>
  <dcterms:modified xsi:type="dcterms:W3CDTF">2024-05-11T09:01:24Z</dcterms:modified>
</cp:coreProperties>
</file>